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103917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33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2108D5-B454-4164-A2EC-EB5FF19C5C08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090613" y="1143000"/>
            <a:ext cx="467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62264F-BD48-4566-B713-14D766BACC3D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63142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1090613" y="1143000"/>
            <a:ext cx="4676775" cy="3086100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dirty="0"/>
              <a:t>Pijninterferentie</a:t>
            </a: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2079CB-32AF-421B-B952-98E711EF14D1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387535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9383" y="1122363"/>
            <a:ext cx="8833009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8972" y="3602038"/>
            <a:ext cx="779383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8414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46907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36615" y="365125"/>
            <a:ext cx="2240726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4435" y="365125"/>
            <a:ext cx="6592282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37548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3929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9023" y="1709740"/>
            <a:ext cx="8962906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9023" y="4589465"/>
            <a:ext cx="8962906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2685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4435" y="1825625"/>
            <a:ext cx="4416504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60836" y="1825625"/>
            <a:ext cx="4416504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98373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365127"/>
            <a:ext cx="8962906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5789" y="1681163"/>
            <a:ext cx="439620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5789" y="2505075"/>
            <a:ext cx="439620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60837" y="1681163"/>
            <a:ext cx="441785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60837" y="2505075"/>
            <a:ext cx="441785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0413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7702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92899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457200"/>
            <a:ext cx="335161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17858" y="987427"/>
            <a:ext cx="526083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788" y="2057400"/>
            <a:ext cx="335161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16558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457200"/>
            <a:ext cx="335161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17858" y="987427"/>
            <a:ext cx="526083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788" y="2057400"/>
            <a:ext cx="335161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74379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4435" y="365127"/>
            <a:ext cx="896290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435" y="1825625"/>
            <a:ext cx="896290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4435" y="6356352"/>
            <a:ext cx="233814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662640-CF1F-4623-804A-4355F51A4653}" type="datetimeFigureOut">
              <a:rPr lang="nl-NL" smtClean="0"/>
              <a:t>14-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2276" y="6356352"/>
            <a:ext cx="350722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39191" y="6356352"/>
            <a:ext cx="233814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AC5A80-C75F-4234-9ECB-93E2365CC7C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67775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3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1DFACBED-0187-9FF5-B872-6601B82670C9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1775" y="0"/>
            <a:ext cx="3420000" cy="2268000"/>
          </a:xfrm>
          <a:prstGeom prst="rect">
            <a:avLst/>
          </a:prstGeom>
        </p:spPr>
      </p:pic>
      <p:pic>
        <p:nvPicPr>
          <p:cNvPr id="7" name="Afbeelding 6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B10A82C7-DFE0-B30C-876A-1AB7323AFEDB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5739" y="4583760"/>
            <a:ext cx="3420000" cy="2268000"/>
          </a:xfrm>
          <a:prstGeom prst="rect">
            <a:avLst/>
          </a:prstGeom>
        </p:spPr>
      </p:pic>
      <p:pic>
        <p:nvPicPr>
          <p:cNvPr id="9" name="Afbeelding 8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975106DD-0E72-F9C2-6079-D007DB0FEDB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775" y="2315760"/>
            <a:ext cx="3420000" cy="2268000"/>
          </a:xfrm>
          <a:prstGeom prst="rect">
            <a:avLst/>
          </a:prstGeom>
        </p:spPr>
      </p:pic>
      <p:pic>
        <p:nvPicPr>
          <p:cNvPr id="12" name="Afbeelding 11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A5D18D59-D940-1C63-7E6F-57AA818522D6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775" y="0"/>
            <a:ext cx="3420000" cy="2268000"/>
          </a:xfrm>
          <a:prstGeom prst="rect">
            <a:avLst/>
          </a:prstGeom>
        </p:spPr>
      </p:pic>
      <p:pic>
        <p:nvPicPr>
          <p:cNvPr id="15" name="Afbeelding 14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333FB9BD-768B-5CB0-CB16-ADE6980906AD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51" y="4590000"/>
            <a:ext cx="3420000" cy="2268000"/>
          </a:xfrm>
          <a:prstGeom prst="rect">
            <a:avLst/>
          </a:prstGeom>
        </p:spPr>
      </p:pic>
      <p:pic>
        <p:nvPicPr>
          <p:cNvPr id="18" name="Afbeelding 17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D9E09FE4-0CB7-C271-AA72-DA511324B4C4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50" y="2305247"/>
            <a:ext cx="3420000" cy="2268000"/>
          </a:xfrm>
          <a:prstGeom prst="rect">
            <a:avLst/>
          </a:prstGeom>
        </p:spPr>
      </p:pic>
      <p:pic>
        <p:nvPicPr>
          <p:cNvPr id="21" name="Afbeelding 20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49E550E3-B657-5E78-0761-D5C159040516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51" y="0"/>
            <a:ext cx="3420000" cy="2268000"/>
          </a:xfrm>
          <a:prstGeom prst="rect">
            <a:avLst/>
          </a:prstGeom>
        </p:spPr>
      </p:pic>
      <p:sp>
        <p:nvSpPr>
          <p:cNvPr id="23" name="Tekstvak 22">
            <a:extLst>
              <a:ext uri="{FF2B5EF4-FFF2-40B4-BE49-F238E27FC236}">
                <a16:creationId xmlns:a16="http://schemas.microsoft.com/office/drawing/2014/main" id="{42978251-2670-6908-4F64-88BC19B27A47}"/>
              </a:ext>
            </a:extLst>
          </p:cNvPr>
          <p:cNvSpPr txBox="1">
            <a:spLocks/>
          </p:cNvSpPr>
          <p:nvPr/>
        </p:nvSpPr>
        <p:spPr>
          <a:xfrm>
            <a:off x="814451" y="324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1</a:t>
            </a:r>
          </a:p>
        </p:txBody>
      </p:sp>
      <p:sp>
        <p:nvSpPr>
          <p:cNvPr id="24" name="Tekstvak 23">
            <a:extLst>
              <a:ext uri="{FF2B5EF4-FFF2-40B4-BE49-F238E27FC236}">
                <a16:creationId xmlns:a16="http://schemas.microsoft.com/office/drawing/2014/main" id="{95486060-E2E6-7A43-F4A5-3082074851FA}"/>
              </a:ext>
            </a:extLst>
          </p:cNvPr>
          <p:cNvSpPr txBox="1">
            <a:spLocks/>
          </p:cNvSpPr>
          <p:nvPr/>
        </p:nvSpPr>
        <p:spPr>
          <a:xfrm>
            <a:off x="814451" y="2628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2</a:t>
            </a:r>
          </a:p>
        </p:txBody>
      </p:sp>
      <p:sp>
        <p:nvSpPr>
          <p:cNvPr id="25" name="Tekstvak 24">
            <a:extLst>
              <a:ext uri="{FF2B5EF4-FFF2-40B4-BE49-F238E27FC236}">
                <a16:creationId xmlns:a16="http://schemas.microsoft.com/office/drawing/2014/main" id="{345551D2-716B-94DE-1E21-C2876CBEF540}"/>
              </a:ext>
            </a:extLst>
          </p:cNvPr>
          <p:cNvSpPr txBox="1">
            <a:spLocks/>
          </p:cNvSpPr>
          <p:nvPr/>
        </p:nvSpPr>
        <p:spPr>
          <a:xfrm>
            <a:off x="4306451" y="324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4</a:t>
            </a:r>
          </a:p>
        </p:txBody>
      </p:sp>
      <p:sp>
        <p:nvSpPr>
          <p:cNvPr id="26" name="Tekstvak 25">
            <a:extLst>
              <a:ext uri="{FF2B5EF4-FFF2-40B4-BE49-F238E27FC236}">
                <a16:creationId xmlns:a16="http://schemas.microsoft.com/office/drawing/2014/main" id="{4A37D714-AB48-B4A3-6278-8524BF071638}"/>
              </a:ext>
            </a:extLst>
          </p:cNvPr>
          <p:cNvSpPr txBox="1">
            <a:spLocks/>
          </p:cNvSpPr>
          <p:nvPr/>
        </p:nvSpPr>
        <p:spPr>
          <a:xfrm>
            <a:off x="814451" y="4860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3</a:t>
            </a:r>
          </a:p>
        </p:txBody>
      </p:sp>
      <p:sp>
        <p:nvSpPr>
          <p:cNvPr id="27" name="Tekstvak 26">
            <a:extLst>
              <a:ext uri="{FF2B5EF4-FFF2-40B4-BE49-F238E27FC236}">
                <a16:creationId xmlns:a16="http://schemas.microsoft.com/office/drawing/2014/main" id="{C283A2EA-2B6F-2D93-0251-2AE457794BD1}"/>
              </a:ext>
            </a:extLst>
          </p:cNvPr>
          <p:cNvSpPr txBox="1">
            <a:spLocks/>
          </p:cNvSpPr>
          <p:nvPr/>
        </p:nvSpPr>
        <p:spPr>
          <a:xfrm>
            <a:off x="7762451" y="324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7</a:t>
            </a:r>
          </a:p>
        </p:txBody>
      </p:sp>
      <p:sp>
        <p:nvSpPr>
          <p:cNvPr id="28" name="Tekstvak 27">
            <a:extLst>
              <a:ext uri="{FF2B5EF4-FFF2-40B4-BE49-F238E27FC236}">
                <a16:creationId xmlns:a16="http://schemas.microsoft.com/office/drawing/2014/main" id="{8C93277B-152B-B6D1-97D7-3BC8FD5BD6DF}"/>
              </a:ext>
            </a:extLst>
          </p:cNvPr>
          <p:cNvSpPr txBox="1">
            <a:spLocks/>
          </p:cNvSpPr>
          <p:nvPr/>
        </p:nvSpPr>
        <p:spPr>
          <a:xfrm>
            <a:off x="4306451" y="2628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5</a:t>
            </a:r>
          </a:p>
        </p:txBody>
      </p:sp>
      <p:sp>
        <p:nvSpPr>
          <p:cNvPr id="29" name="Tekstvak 28">
            <a:extLst>
              <a:ext uri="{FF2B5EF4-FFF2-40B4-BE49-F238E27FC236}">
                <a16:creationId xmlns:a16="http://schemas.microsoft.com/office/drawing/2014/main" id="{F7C3DCA1-241C-7A56-1ED0-9D6EB2713E2E}"/>
              </a:ext>
            </a:extLst>
          </p:cNvPr>
          <p:cNvSpPr txBox="1">
            <a:spLocks/>
          </p:cNvSpPr>
          <p:nvPr/>
        </p:nvSpPr>
        <p:spPr>
          <a:xfrm>
            <a:off x="4306451" y="486000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6</a:t>
            </a:r>
          </a:p>
        </p:txBody>
      </p:sp>
    </p:spTree>
    <p:extLst>
      <p:ext uri="{BB962C8B-B14F-4D97-AF65-F5344CB8AC3E}">
        <p14:creationId xmlns:p14="http://schemas.microsoft.com/office/powerpoint/2010/main" val="278372008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Kantoorth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Office PowerPoint</Application>
  <PresentationFormat>Aangepast</PresentationFormat>
  <Paragraphs>9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yl Slatman</dc:creator>
  <cp:lastModifiedBy>Syl Slatman</cp:lastModifiedBy>
  <cp:revision>3</cp:revision>
  <dcterms:created xsi:type="dcterms:W3CDTF">2024-09-23T09:31:43Z</dcterms:created>
  <dcterms:modified xsi:type="dcterms:W3CDTF">2025-01-14T16:43:46Z</dcterms:modified>
</cp:coreProperties>
</file>